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9397492"/>
              </p:ext>
            </p:extLst>
          </p:nvPr>
        </p:nvGraphicFramePr>
        <p:xfrm>
          <a:off x="244549" y="1132666"/>
          <a:ext cx="6507126" cy="729041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99240">
                  <a:extLst>
                    <a:ext uri="{9D8B030D-6E8A-4147-A177-3AD203B41FA5}">
                      <a16:colId xmlns:a16="http://schemas.microsoft.com/office/drawing/2014/main" xmlns="" val="538729835"/>
                    </a:ext>
                  </a:extLst>
                </a:gridCol>
                <a:gridCol w="170749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9915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69937">
                  <a:extLst>
                    <a:ext uri="{9D8B030D-6E8A-4147-A177-3AD203B41FA5}">
                      <a16:colId xmlns:a16="http://schemas.microsoft.com/office/drawing/2014/main" xmlns="" val="2680922805"/>
                    </a:ext>
                  </a:extLst>
                </a:gridCol>
                <a:gridCol w="72053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70785">
                  <a:extLst>
                    <a:ext uri="{9D8B030D-6E8A-4147-A177-3AD203B41FA5}">
                      <a16:colId xmlns:a16="http://schemas.microsoft.com/office/drawing/2014/main" xmlns="" val="1295131219"/>
                    </a:ext>
                  </a:extLst>
                </a:gridCol>
                <a:gridCol w="839973">
                  <a:extLst>
                    <a:ext uri="{9D8B030D-6E8A-4147-A177-3AD203B41FA5}">
                      <a16:colId xmlns:a16="http://schemas.microsoft.com/office/drawing/2014/main" xmlns="" val="1108653980"/>
                    </a:ext>
                  </a:extLst>
                </a:gridCol>
              </a:tblGrid>
              <a:tr h="345260">
                <a:tc rowSpan="2" gridSpan="2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BC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57714">
                <a:tc gridSpan="2" vMerge="1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242567296"/>
                  </a:ext>
                </a:extLst>
              </a:tr>
              <a:tr h="332118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8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6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06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7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5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19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953843220"/>
                  </a:ext>
                </a:extLst>
              </a:tr>
              <a:tr h="33211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7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6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10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932488495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63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344560836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6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1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50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682801712"/>
                  </a:ext>
                </a:extLst>
              </a:tr>
              <a:tr h="331234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5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3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75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156766006"/>
                  </a:ext>
                </a:extLst>
              </a:tr>
              <a:tr h="324765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7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6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24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4020587007"/>
                  </a:ext>
                </a:extLst>
              </a:tr>
              <a:tr h="33123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9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56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257079666"/>
                  </a:ext>
                </a:extLst>
              </a:tr>
              <a:tr h="33123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0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0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64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135161066"/>
                  </a:ext>
                </a:extLst>
              </a:tr>
              <a:tr h="33123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5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6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68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318631953"/>
                  </a:ext>
                </a:extLst>
              </a:tr>
              <a:tr h="263649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4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1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71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535162925"/>
                  </a:ext>
                </a:extLst>
              </a:tr>
              <a:tr h="33476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4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6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61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581980012"/>
                  </a:ext>
                </a:extLst>
              </a:tr>
              <a:tr h="33477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12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557972939"/>
                  </a:ext>
                </a:extLst>
              </a:tr>
              <a:tr h="33476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9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5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53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919492204"/>
                  </a:ext>
                </a:extLst>
              </a:tr>
              <a:tr h="33476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95</a:t>
                      </a:r>
                    </a:p>
                  </a:txBody>
                  <a:tcPr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951859"/>
                  </a:ext>
                </a:extLst>
              </a:tr>
              <a:tr h="332118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9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3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31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3983687065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3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8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57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352678447"/>
                  </a:ext>
                </a:extLst>
              </a:tr>
              <a:tr h="28249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9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4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41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011297306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5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26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27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38548013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5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13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258059024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62996" y="492717"/>
            <a:ext cx="56466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. ICP expression differences between TNBC and other breast cancer subtype patients</a:t>
            </a:r>
          </a:p>
        </p:txBody>
      </p:sp>
    </p:spTree>
    <p:extLst>
      <p:ext uri="{BB962C8B-B14F-4D97-AF65-F5344CB8AC3E}">
        <p14:creationId xmlns:p14="http://schemas.microsoft.com/office/powerpoint/2010/main" val="3726147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182</Words>
  <Application>Microsoft Office PowerPoint</Application>
  <PresentationFormat>Custom</PresentationFormat>
  <Paragraphs>1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10:10Z</dcterms:modified>
</cp:coreProperties>
</file>